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Honokiol%20Monoacetato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5442642979488203E-2"/>
          <c:y val="9.4174835288446095E-3"/>
          <c:w val="0.83385616409435459"/>
          <c:h val="0.8519520327816165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Graph!$D$23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E$24:$E$38</c:f>
                <c:numCache>
                  <c:formatCode>General</c:formatCode>
                  <c:ptCount val="15"/>
                  <c:pt idx="0">
                    <c:v>3.0746875782270426</c:v>
                  </c:pt>
                  <c:pt idx="1">
                    <c:v>3.2545361262705637</c:v>
                  </c:pt>
                  <c:pt idx="2">
                    <c:v>9.3795408961084465</c:v>
                  </c:pt>
                  <c:pt idx="3">
                    <c:v>2.2138046835535454</c:v>
                  </c:pt>
                  <c:pt idx="4">
                    <c:v>2.0367003088692619</c:v>
                  </c:pt>
                  <c:pt idx="5">
                    <c:v>13.936040980439243</c:v>
                  </c:pt>
                  <c:pt idx="6">
                    <c:v>1.332346775052982</c:v>
                  </c:pt>
                  <c:pt idx="7">
                    <c:v>2.3094010767585029</c:v>
                  </c:pt>
                  <c:pt idx="8">
                    <c:v>0.62080674106411526</c:v>
                  </c:pt>
                  <c:pt idx="9">
                    <c:v>3.4815302670047275</c:v>
                  </c:pt>
                  <c:pt idx="10">
                    <c:v>1.8184824186332695</c:v>
                  </c:pt>
                  <c:pt idx="11">
                    <c:v>1.9245008972987498</c:v>
                  </c:pt>
                  <c:pt idx="12">
                    <c:v>1.9245008972987518</c:v>
                  </c:pt>
                  <c:pt idx="13">
                    <c:v>5.9112435907306864</c:v>
                  </c:pt>
                  <c:pt idx="14">
                    <c:v>0</c:v>
                  </c:pt>
                </c:numCache>
              </c:numRef>
            </c:plus>
            <c:minus>
              <c:numRef>
                <c:f>Graph!$E$24:$E$38</c:f>
                <c:numCache>
                  <c:formatCode>General</c:formatCode>
                  <c:ptCount val="15"/>
                  <c:pt idx="0">
                    <c:v>3.0746875782270426</c:v>
                  </c:pt>
                  <c:pt idx="1">
                    <c:v>3.2545361262705637</c:v>
                  </c:pt>
                  <c:pt idx="2">
                    <c:v>9.3795408961084465</c:v>
                  </c:pt>
                  <c:pt idx="3">
                    <c:v>2.2138046835535454</c:v>
                  </c:pt>
                  <c:pt idx="4">
                    <c:v>2.0367003088692619</c:v>
                  </c:pt>
                  <c:pt idx="5">
                    <c:v>13.936040980439243</c:v>
                  </c:pt>
                  <c:pt idx="6">
                    <c:v>1.332346775052982</c:v>
                  </c:pt>
                  <c:pt idx="7">
                    <c:v>2.3094010767585029</c:v>
                  </c:pt>
                  <c:pt idx="8">
                    <c:v>0.62080674106411526</c:v>
                  </c:pt>
                  <c:pt idx="9">
                    <c:v>3.4815302670047275</c:v>
                  </c:pt>
                  <c:pt idx="10">
                    <c:v>1.8184824186332695</c:v>
                  </c:pt>
                  <c:pt idx="11">
                    <c:v>1.9245008972987498</c:v>
                  </c:pt>
                  <c:pt idx="12">
                    <c:v>1.9245008972987518</c:v>
                  </c:pt>
                  <c:pt idx="13">
                    <c:v>5.9112435907306864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Graph!$C$24:$C$38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4:$D$38</c:f>
              <c:numCache>
                <c:formatCode>0.0</c:formatCode>
                <c:ptCount val="15"/>
                <c:pt idx="0">
                  <c:v>46.611111111111114</c:v>
                </c:pt>
                <c:pt idx="1">
                  <c:v>39.740259740259738</c:v>
                </c:pt>
                <c:pt idx="2">
                  <c:v>10.818713450292398</c:v>
                </c:pt>
                <c:pt idx="3">
                  <c:v>32.850241545893716</c:v>
                </c:pt>
                <c:pt idx="4">
                  <c:v>33.777777777777779</c:v>
                </c:pt>
                <c:pt idx="5">
                  <c:v>16.091954022988507</c:v>
                </c:pt>
                <c:pt idx="6">
                  <c:v>58.46153846153846</c:v>
                </c:pt>
                <c:pt idx="7">
                  <c:v>54.666666666666664</c:v>
                </c:pt>
                <c:pt idx="8">
                  <c:v>32.974910394265237</c:v>
                </c:pt>
                <c:pt idx="9">
                  <c:v>61.473429951690832</c:v>
                </c:pt>
                <c:pt idx="10">
                  <c:v>33.730158730158735</c:v>
                </c:pt>
                <c:pt idx="11">
                  <c:v>35.555555555555564</c:v>
                </c:pt>
                <c:pt idx="12">
                  <c:v>28.888888888888889</c:v>
                </c:pt>
                <c:pt idx="13">
                  <c:v>6.5128205128205137</c:v>
                </c:pt>
                <c:pt idx="14">
                  <c:v>34.7826086956521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9CD-4F22-A680-5FAB1FF5D59B}"/>
            </c:ext>
          </c:extLst>
        </c:ser>
        <c:ser>
          <c:idx val="3"/>
          <c:order val="1"/>
          <c:tx>
            <c:strRef>
              <c:f>Graph!$F$23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FD01FD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G$24:$G$38</c:f>
                <c:numCache>
                  <c:formatCode>General</c:formatCode>
                  <c:ptCount val="15"/>
                  <c:pt idx="0">
                    <c:v>7.1949811181462087</c:v>
                  </c:pt>
                  <c:pt idx="1">
                    <c:v>2.5009446439029768</c:v>
                  </c:pt>
                  <c:pt idx="2">
                    <c:v>4.1796845306806167</c:v>
                  </c:pt>
                  <c:pt idx="3">
                    <c:v>2.7073906481619066</c:v>
                  </c:pt>
                  <c:pt idx="4">
                    <c:v>1.1547005383792517</c:v>
                  </c:pt>
                  <c:pt idx="5">
                    <c:v>3.4482758620689644</c:v>
                  </c:pt>
                  <c:pt idx="6">
                    <c:v>4.6367029025705424</c:v>
                  </c:pt>
                  <c:pt idx="7">
                    <c:v>0</c:v>
                  </c:pt>
                  <c:pt idx="8">
                    <c:v>0.99329078570258522</c:v>
                  </c:pt>
                  <c:pt idx="9">
                    <c:v>1.6734790411293534</c:v>
                  </c:pt>
                  <c:pt idx="10">
                    <c:v>3.0547633290456351</c:v>
                  </c:pt>
                  <c:pt idx="11">
                    <c:v>2.9742286594617071</c:v>
                  </c:pt>
                  <c:pt idx="12">
                    <c:v>1.9245008972987498</c:v>
                  </c:pt>
                  <c:pt idx="13">
                    <c:v>1.9641762053544161</c:v>
                  </c:pt>
                  <c:pt idx="14">
                    <c:v>2.510218561694022</c:v>
                  </c:pt>
                </c:numCache>
              </c:numRef>
            </c:plus>
            <c:minus>
              <c:numRef>
                <c:f>Graph!$G$24:$G$38</c:f>
                <c:numCache>
                  <c:formatCode>General</c:formatCode>
                  <c:ptCount val="15"/>
                  <c:pt idx="0">
                    <c:v>7.1949811181462087</c:v>
                  </c:pt>
                  <c:pt idx="1">
                    <c:v>2.5009446439029768</c:v>
                  </c:pt>
                  <c:pt idx="2">
                    <c:v>4.1796845306806167</c:v>
                  </c:pt>
                  <c:pt idx="3">
                    <c:v>2.7073906481619066</c:v>
                  </c:pt>
                  <c:pt idx="4">
                    <c:v>1.1547005383792517</c:v>
                  </c:pt>
                  <c:pt idx="5">
                    <c:v>3.4482758620689644</c:v>
                  </c:pt>
                  <c:pt idx="6">
                    <c:v>4.6367029025705424</c:v>
                  </c:pt>
                  <c:pt idx="7">
                    <c:v>0</c:v>
                  </c:pt>
                  <c:pt idx="8">
                    <c:v>0.99329078570258522</c:v>
                  </c:pt>
                  <c:pt idx="9">
                    <c:v>1.6734790411293534</c:v>
                  </c:pt>
                  <c:pt idx="10">
                    <c:v>3.0547633290456351</c:v>
                  </c:pt>
                  <c:pt idx="11">
                    <c:v>2.9742286594617071</c:v>
                  </c:pt>
                  <c:pt idx="12">
                    <c:v>1.9245008972987498</c:v>
                  </c:pt>
                  <c:pt idx="13">
                    <c:v>1.9641762053544161</c:v>
                  </c:pt>
                  <c:pt idx="14">
                    <c:v>2.510218561694022</c:v>
                  </c:pt>
                </c:numCache>
              </c:numRef>
            </c:minus>
          </c:errBars>
          <c:cat>
            <c:strRef>
              <c:f>Graph!$C$24:$C$38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4:$F$38</c:f>
              <c:numCache>
                <c:formatCode>0.0</c:formatCode>
                <c:ptCount val="15"/>
                <c:pt idx="0">
                  <c:v>62.116161616161627</c:v>
                </c:pt>
                <c:pt idx="1">
                  <c:v>52.460317460317469</c:v>
                </c:pt>
                <c:pt idx="2">
                  <c:v>50.974658869395718</c:v>
                </c:pt>
                <c:pt idx="3">
                  <c:v>55.279503105590067</c:v>
                </c:pt>
                <c:pt idx="4">
                  <c:v>48.666666666666664</c:v>
                </c:pt>
                <c:pt idx="5">
                  <c:v>44.827586206896548</c:v>
                </c:pt>
                <c:pt idx="6">
                  <c:v>64.871794871794876</c:v>
                </c:pt>
                <c:pt idx="7">
                  <c:v>76</c:v>
                </c:pt>
                <c:pt idx="8">
                  <c:v>52.759856630824373</c:v>
                </c:pt>
                <c:pt idx="9">
                  <c:v>68.59903381642512</c:v>
                </c:pt>
                <c:pt idx="10">
                  <c:v>44.620811287477956</c:v>
                </c:pt>
                <c:pt idx="11">
                  <c:v>54.949494949494948</c:v>
                </c:pt>
                <c:pt idx="12">
                  <c:v>45.55555555555555</c:v>
                </c:pt>
                <c:pt idx="13">
                  <c:v>32.46153846153846</c:v>
                </c:pt>
                <c:pt idx="14">
                  <c:v>49.2753623188405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9CD-4F22-A680-5FAB1FF5D59B}"/>
            </c:ext>
          </c:extLst>
        </c:ser>
        <c:ser>
          <c:idx val="5"/>
          <c:order val="2"/>
          <c:tx>
            <c:strRef>
              <c:f>Graph!$H$23</c:f>
              <c:strCache>
                <c:ptCount val="1"/>
                <c:pt idx="0">
                  <c:v>25 µg/ml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I$24:$I$38</c:f>
                <c:numCache>
                  <c:formatCode>General</c:formatCode>
                  <c:ptCount val="15"/>
                  <c:pt idx="0">
                    <c:v>8.1353901567629077</c:v>
                  </c:pt>
                  <c:pt idx="1">
                    <c:v>6.3274708308145708</c:v>
                  </c:pt>
                  <c:pt idx="2">
                    <c:v>0.84407934092051307</c:v>
                  </c:pt>
                  <c:pt idx="3">
                    <c:v>6.4159928460325526</c:v>
                  </c:pt>
                  <c:pt idx="4">
                    <c:v>2.0816659994661326</c:v>
                  </c:pt>
                  <c:pt idx="5">
                    <c:v>0</c:v>
                  </c:pt>
                  <c:pt idx="6">
                    <c:v>2.0659730336906446</c:v>
                  </c:pt>
                  <c:pt idx="7">
                    <c:v>2.3094010767584865</c:v>
                  </c:pt>
                  <c:pt idx="8">
                    <c:v>2.2563570947006633</c:v>
                  </c:pt>
                  <c:pt idx="9">
                    <c:v>3.9909931502073217</c:v>
                  </c:pt>
                  <c:pt idx="10">
                    <c:v>5.0634487548344227</c:v>
                  </c:pt>
                  <c:pt idx="11">
                    <c:v>9.8488733412108633</c:v>
                  </c:pt>
                  <c:pt idx="12">
                    <c:v>1.9245008972987581</c:v>
                  </c:pt>
                  <c:pt idx="13">
                    <c:v>5.4203939535277197</c:v>
                  </c:pt>
                  <c:pt idx="14">
                    <c:v>7.5306556850820741</c:v>
                  </c:pt>
                </c:numCache>
              </c:numRef>
            </c:plus>
            <c:minus>
              <c:numRef>
                <c:f>Graph!$I$24:$I$38</c:f>
                <c:numCache>
                  <c:formatCode>General</c:formatCode>
                  <c:ptCount val="15"/>
                  <c:pt idx="0">
                    <c:v>8.1353901567629077</c:v>
                  </c:pt>
                  <c:pt idx="1">
                    <c:v>6.3274708308145708</c:v>
                  </c:pt>
                  <c:pt idx="2">
                    <c:v>0.84407934092051307</c:v>
                  </c:pt>
                  <c:pt idx="3">
                    <c:v>6.4159928460325526</c:v>
                  </c:pt>
                  <c:pt idx="4">
                    <c:v>2.0816659994661326</c:v>
                  </c:pt>
                  <c:pt idx="5">
                    <c:v>0</c:v>
                  </c:pt>
                  <c:pt idx="6">
                    <c:v>2.0659730336906446</c:v>
                  </c:pt>
                  <c:pt idx="7">
                    <c:v>2.3094010767584865</c:v>
                  </c:pt>
                  <c:pt idx="8">
                    <c:v>2.2563570947006633</c:v>
                  </c:pt>
                  <c:pt idx="9">
                    <c:v>3.9909931502073217</c:v>
                  </c:pt>
                  <c:pt idx="10">
                    <c:v>5.0634487548344227</c:v>
                  </c:pt>
                  <c:pt idx="11">
                    <c:v>9.8488733412108633</c:v>
                  </c:pt>
                  <c:pt idx="12">
                    <c:v>1.9245008972987581</c:v>
                  </c:pt>
                  <c:pt idx="13">
                    <c:v>5.4203939535277197</c:v>
                  </c:pt>
                  <c:pt idx="14">
                    <c:v>7.5306556850820741</c:v>
                  </c:pt>
                </c:numCache>
              </c:numRef>
            </c:minus>
          </c:errBars>
          <c:cat>
            <c:strRef>
              <c:f>Graph!$C$24:$C$38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4:$H$38</c:f>
              <c:numCache>
                <c:formatCode>0.0</c:formatCode>
                <c:ptCount val="15"/>
                <c:pt idx="0">
                  <c:v>81.969696969696969</c:v>
                </c:pt>
                <c:pt idx="1">
                  <c:v>77.97258297258297</c:v>
                </c:pt>
                <c:pt idx="2">
                  <c:v>72.709551656920084</c:v>
                </c:pt>
                <c:pt idx="3">
                  <c:v>88.267770876466543</c:v>
                </c:pt>
                <c:pt idx="4">
                  <c:v>74.333333333333329</c:v>
                </c:pt>
                <c:pt idx="5">
                  <c:v>75.862068965517253</c:v>
                </c:pt>
                <c:pt idx="6">
                  <c:v>83.128205128205124</c:v>
                </c:pt>
                <c:pt idx="7">
                  <c:v>89.333333333333329</c:v>
                </c:pt>
                <c:pt idx="8">
                  <c:v>69.211469534050181</c:v>
                </c:pt>
                <c:pt idx="9">
                  <c:v>87.198067632850254</c:v>
                </c:pt>
                <c:pt idx="10">
                  <c:v>69.929453262786595</c:v>
                </c:pt>
                <c:pt idx="11">
                  <c:v>73.434343434343432</c:v>
                </c:pt>
                <c:pt idx="12">
                  <c:v>72.222222222222229</c:v>
                </c:pt>
                <c:pt idx="13">
                  <c:v>67.589743589743591</c:v>
                </c:pt>
                <c:pt idx="14">
                  <c:v>69.5652173913043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9CD-4F22-A680-5FAB1FF5D59B}"/>
            </c:ext>
          </c:extLst>
        </c:ser>
        <c:ser>
          <c:idx val="7"/>
          <c:order val="3"/>
          <c:tx>
            <c:strRef>
              <c:f>Graph!$J$23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4:$K$38</c:f>
                <c:numCache>
                  <c:formatCode>General</c:formatCode>
                  <c:ptCount val="15"/>
                  <c:pt idx="0">
                    <c:v>11.182310903162453</c:v>
                  </c:pt>
                  <c:pt idx="1">
                    <c:v>6.0321430166867245</c:v>
                  </c:pt>
                  <c:pt idx="2">
                    <c:v>2.8399224725796168</c:v>
                  </c:pt>
                  <c:pt idx="3">
                    <c:v>4.7813686889409999</c:v>
                  </c:pt>
                  <c:pt idx="4">
                    <c:v>3.3554819712314465</c:v>
                  </c:pt>
                  <c:pt idx="5">
                    <c:v>0</c:v>
                  </c:pt>
                  <c:pt idx="6">
                    <c:v>1.9541086034110422</c:v>
                  </c:pt>
                  <c:pt idx="7">
                    <c:v>2.3094010767585034</c:v>
                  </c:pt>
                  <c:pt idx="8">
                    <c:v>4.5973243712756924</c:v>
                  </c:pt>
                  <c:pt idx="9">
                    <c:v>0.3137773202117517</c:v>
                  </c:pt>
                  <c:pt idx="10">
                    <c:v>3.4366087451763376</c:v>
                  </c:pt>
                  <c:pt idx="11">
                    <c:v>3.4990925405431876</c:v>
                  </c:pt>
                  <c:pt idx="12">
                    <c:v>3.8490017945975077</c:v>
                  </c:pt>
                  <c:pt idx="13">
                    <c:v>0.97705430170552121</c:v>
                  </c:pt>
                  <c:pt idx="14">
                    <c:v>2.5102185616940216</c:v>
                  </c:pt>
                </c:numCache>
              </c:numRef>
            </c:plus>
            <c:minus>
              <c:numRef>
                <c:f>Graph!$K$24:$K$38</c:f>
                <c:numCache>
                  <c:formatCode>General</c:formatCode>
                  <c:ptCount val="15"/>
                  <c:pt idx="0">
                    <c:v>11.182310903162453</c:v>
                  </c:pt>
                  <c:pt idx="1">
                    <c:v>6.0321430166867245</c:v>
                  </c:pt>
                  <c:pt idx="2">
                    <c:v>2.8399224725796168</c:v>
                  </c:pt>
                  <c:pt idx="3">
                    <c:v>4.7813686889409999</c:v>
                  </c:pt>
                  <c:pt idx="4">
                    <c:v>3.3554819712314465</c:v>
                  </c:pt>
                  <c:pt idx="5">
                    <c:v>0</c:v>
                  </c:pt>
                  <c:pt idx="6">
                    <c:v>1.9541086034110422</c:v>
                  </c:pt>
                  <c:pt idx="7">
                    <c:v>2.3094010767585034</c:v>
                  </c:pt>
                  <c:pt idx="8">
                    <c:v>4.5973243712756924</c:v>
                  </c:pt>
                  <c:pt idx="9">
                    <c:v>0.3137773202117517</c:v>
                  </c:pt>
                  <c:pt idx="10">
                    <c:v>3.4366087451763376</c:v>
                  </c:pt>
                  <c:pt idx="11">
                    <c:v>3.4990925405431876</c:v>
                  </c:pt>
                  <c:pt idx="12">
                    <c:v>3.8490017945975077</c:v>
                  </c:pt>
                  <c:pt idx="13">
                    <c:v>0.97705430170552121</c:v>
                  </c:pt>
                  <c:pt idx="14">
                    <c:v>2.5102185616940216</c:v>
                  </c:pt>
                </c:numCache>
              </c:numRef>
            </c:minus>
          </c:errBars>
          <c:cat>
            <c:strRef>
              <c:f>Graph!$C$24:$C$38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4:$J$38</c:f>
              <c:numCache>
                <c:formatCode>0.0</c:formatCode>
                <c:ptCount val="15"/>
                <c:pt idx="0">
                  <c:v>75.121212121212125</c:v>
                </c:pt>
                <c:pt idx="1">
                  <c:v>74.790764790764797</c:v>
                </c:pt>
                <c:pt idx="2">
                  <c:v>69.103313840155934</c:v>
                </c:pt>
                <c:pt idx="3">
                  <c:v>89.717046238785372</c:v>
                </c:pt>
                <c:pt idx="4">
                  <c:v>63.555555555555564</c:v>
                </c:pt>
                <c:pt idx="5">
                  <c:v>68.965517241379317</c:v>
                </c:pt>
                <c:pt idx="6">
                  <c:v>85.743589743589766</c:v>
                </c:pt>
                <c:pt idx="7">
                  <c:v>81.333333333333329</c:v>
                </c:pt>
                <c:pt idx="8">
                  <c:v>68.172043010752702</c:v>
                </c:pt>
                <c:pt idx="9">
                  <c:v>87.137681159420296</c:v>
                </c:pt>
                <c:pt idx="10">
                  <c:v>62.698412698412703</c:v>
                </c:pt>
                <c:pt idx="11">
                  <c:v>64.646464646464651</c:v>
                </c:pt>
                <c:pt idx="12">
                  <c:v>61.111111111111114</c:v>
                </c:pt>
                <c:pt idx="13">
                  <c:v>57.128205128205131</c:v>
                </c:pt>
                <c:pt idx="14">
                  <c:v>71.0144927536232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9CD-4F22-A680-5FAB1FF5D59B}"/>
            </c:ext>
          </c:extLst>
        </c:ser>
        <c:ser>
          <c:idx val="9"/>
          <c:order val="4"/>
          <c:tx>
            <c:strRef>
              <c:f>Graph!$L$23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!$M$24:$M$38</c:f>
                <c:numCache>
                  <c:formatCode>General</c:formatCode>
                  <c:ptCount val="15"/>
                  <c:pt idx="0">
                    <c:v>10.93985561016917</c:v>
                  </c:pt>
                  <c:pt idx="1">
                    <c:v>4.7745306838147679</c:v>
                  </c:pt>
                  <c:pt idx="2">
                    <c:v>2.986657591821551</c:v>
                  </c:pt>
                  <c:pt idx="3">
                    <c:v>5.2595055578350953</c:v>
                  </c:pt>
                  <c:pt idx="4">
                    <c:v>2.0207259421636903</c:v>
                  </c:pt>
                  <c:pt idx="5">
                    <c:v>1.9908629972056073</c:v>
                  </c:pt>
                  <c:pt idx="6">
                    <c:v>8.8823118336861087E-2</c:v>
                  </c:pt>
                  <c:pt idx="7">
                    <c:v>0</c:v>
                  </c:pt>
                  <c:pt idx="8">
                    <c:v>1.8131383326081336</c:v>
                  </c:pt>
                  <c:pt idx="9">
                    <c:v>2.6210790355326972</c:v>
                  </c:pt>
                  <c:pt idx="10">
                    <c:v>0.22910724967842827</c:v>
                  </c:pt>
                  <c:pt idx="11">
                    <c:v>4.5990110859928066</c:v>
                  </c:pt>
                  <c:pt idx="12">
                    <c:v>0</c:v>
                  </c:pt>
                  <c:pt idx="13">
                    <c:v>2.1372990752999712</c:v>
                  </c:pt>
                  <c:pt idx="14">
                    <c:v>5.02043712338806</c:v>
                  </c:pt>
                </c:numCache>
              </c:numRef>
            </c:plus>
            <c:minus>
              <c:numRef>
                <c:f>Graph!$M$24:$M$38</c:f>
                <c:numCache>
                  <c:formatCode>General</c:formatCode>
                  <c:ptCount val="15"/>
                  <c:pt idx="0">
                    <c:v>10.93985561016917</c:v>
                  </c:pt>
                  <c:pt idx="1">
                    <c:v>4.7745306838147679</c:v>
                  </c:pt>
                  <c:pt idx="2">
                    <c:v>2.986657591821551</c:v>
                  </c:pt>
                  <c:pt idx="3">
                    <c:v>5.2595055578350953</c:v>
                  </c:pt>
                  <c:pt idx="4">
                    <c:v>2.0207259421636903</c:v>
                  </c:pt>
                  <c:pt idx="5">
                    <c:v>1.9908629972056073</c:v>
                  </c:pt>
                  <c:pt idx="6">
                    <c:v>8.8823118336861087E-2</c:v>
                  </c:pt>
                  <c:pt idx="7">
                    <c:v>0</c:v>
                  </c:pt>
                  <c:pt idx="8">
                    <c:v>1.8131383326081336</c:v>
                  </c:pt>
                  <c:pt idx="9">
                    <c:v>2.6210790355326972</c:v>
                  </c:pt>
                  <c:pt idx="10">
                    <c:v>0.22910724967842827</c:v>
                  </c:pt>
                  <c:pt idx="11">
                    <c:v>4.5990110859928066</c:v>
                  </c:pt>
                  <c:pt idx="12">
                    <c:v>0</c:v>
                  </c:pt>
                  <c:pt idx="13">
                    <c:v>2.1372990752999712</c:v>
                  </c:pt>
                  <c:pt idx="14">
                    <c:v>5.02043712338806</c:v>
                  </c:pt>
                </c:numCache>
              </c:numRef>
            </c:minus>
          </c:errBars>
          <c:cat>
            <c:strRef>
              <c:f>Graph!$C$24:$C$38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4:$L$38</c:f>
              <c:numCache>
                <c:formatCode>0.0</c:formatCode>
                <c:ptCount val="15"/>
                <c:pt idx="0">
                  <c:v>101.87878787878788</c:v>
                </c:pt>
                <c:pt idx="1">
                  <c:v>100.15151515151514</c:v>
                </c:pt>
                <c:pt idx="2">
                  <c:v>85.477582846003884</c:v>
                </c:pt>
                <c:pt idx="3">
                  <c:v>98.688750862663923</c:v>
                </c:pt>
                <c:pt idx="4">
                  <c:v>85.166666666666671</c:v>
                </c:pt>
                <c:pt idx="5">
                  <c:v>88.505747126436788</c:v>
                </c:pt>
                <c:pt idx="6">
                  <c:v>96.102564102564088</c:v>
                </c:pt>
                <c:pt idx="7">
                  <c:v>96</c:v>
                </c:pt>
                <c:pt idx="8">
                  <c:v>87.921146953405014</c:v>
                </c:pt>
                <c:pt idx="9">
                  <c:v>110.024154589372</c:v>
                </c:pt>
                <c:pt idx="10">
                  <c:v>89.153439153439152</c:v>
                </c:pt>
                <c:pt idx="11">
                  <c:v>95.858585858585869</c:v>
                </c:pt>
                <c:pt idx="12">
                  <c:v>100</c:v>
                </c:pt>
                <c:pt idx="13">
                  <c:v>90.923076923076906</c:v>
                </c:pt>
                <c:pt idx="14">
                  <c:v>89.855072463768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9CD-4F22-A680-5FAB1FF5D59B}"/>
            </c:ext>
          </c:extLst>
        </c:ser>
        <c:ser>
          <c:idx val="0"/>
          <c:order val="5"/>
          <c:tx>
            <c:strRef>
              <c:f>Graph!$N$23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N$24:$N$38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C05-4E7C-8E7D-D97F55385B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994296"/>
        <c:axId val="11989984"/>
      </c:barChart>
      <c:catAx>
        <c:axId val="11994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  <c:crossAx val="11989984"/>
        <c:crosses val="autoZero"/>
        <c:auto val="1"/>
        <c:lblAlgn val="ctr"/>
        <c:lblOffset val="100"/>
        <c:noMultiLvlLbl val="0"/>
      </c:catAx>
      <c:valAx>
        <c:axId val="11989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 diameter (% relative to control) </a:t>
                </a:r>
              </a:p>
            </c:rich>
          </c:tx>
          <c:layout>
            <c:manualLayout>
              <c:xMode val="edge"/>
              <c:yMode val="edge"/>
              <c:x val="2.6834385095083787E-2"/>
              <c:y val="0.3514925745041363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1199429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1256</cdr:x>
      <cdr:y>0.11581</cdr:y>
    </cdr:from>
    <cdr:to>
      <cdr:x>0.63898</cdr:x>
      <cdr:y>0.15536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5338661" y="864856"/>
          <a:ext cx="230260" cy="2953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6766</cdr:x>
      <cdr:y>0.48087</cdr:y>
    </cdr:from>
    <cdr:to>
      <cdr:x>0.10055</cdr:x>
      <cdr:y>0.52076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589687" y="3590926"/>
          <a:ext cx="286614" cy="2979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7048</cdr:x>
      <cdr:y>0.29922</cdr:y>
    </cdr:from>
    <cdr:to>
      <cdr:x>0.10383</cdr:x>
      <cdr:y>0.37834</cdr:y>
    </cdr:to>
    <cdr:sp macro="" textlink="">
      <cdr:nvSpPr>
        <cdr:cNvPr id="5" name="CasellaDiTesto 4"/>
        <cdr:cNvSpPr txBox="1"/>
      </cdr:nvSpPr>
      <cdr:spPr>
        <a:xfrm xmlns:a="http://schemas.openxmlformats.org/drawingml/2006/main" rot="16200000">
          <a:off x="464131" y="2384545"/>
          <a:ext cx="590837" cy="2906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08103</cdr:x>
      <cdr:y>0.1693</cdr:y>
    </cdr:from>
    <cdr:to>
      <cdr:x>0.15273</cdr:x>
      <cdr:y>0.22784</cdr:y>
    </cdr:to>
    <cdr:sp macro="" textlink="">
      <cdr:nvSpPr>
        <cdr:cNvPr id="6" name="CasellaDiTesto 5"/>
        <cdr:cNvSpPr txBox="1"/>
      </cdr:nvSpPr>
      <cdr:spPr>
        <a:xfrm xmlns:a="http://schemas.openxmlformats.org/drawingml/2006/main" rot="16200000">
          <a:off x="800118" y="1170395"/>
          <a:ext cx="437153" cy="6248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0915</cdr:x>
      <cdr:y>0.19933</cdr:y>
    </cdr:from>
    <cdr:to>
      <cdr:x>0.1632</cdr:x>
      <cdr:y>0.25787</cdr:y>
    </cdr:to>
    <cdr:sp macro="" textlink="">
      <cdr:nvSpPr>
        <cdr:cNvPr id="7" name="CasellaDiTesto 1"/>
        <cdr:cNvSpPr txBox="1"/>
      </cdr:nvSpPr>
      <cdr:spPr>
        <a:xfrm xmlns:a="http://schemas.openxmlformats.org/drawingml/2006/main" rot="16200000">
          <a:off x="891344" y="1394643"/>
          <a:ext cx="437154" cy="6248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09679</cdr:x>
      <cdr:y>0.03384</cdr:y>
    </cdr:from>
    <cdr:to>
      <cdr:x>0.12446</cdr:x>
      <cdr:y>0.07182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843589" y="252696"/>
          <a:ext cx="241154" cy="2836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2435</cdr:x>
      <cdr:y>0.52541</cdr:y>
    </cdr:from>
    <cdr:to>
      <cdr:x>0.14951</cdr:x>
      <cdr:y>0.56655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1083770" y="3923563"/>
          <a:ext cx="219279" cy="3072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3409</cdr:x>
      <cdr:y>0.44247</cdr:y>
    </cdr:from>
    <cdr:to>
      <cdr:x>0.16806</cdr:x>
      <cdr:y>0.48994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168622" y="3304152"/>
          <a:ext cx="296060" cy="3544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4814</cdr:x>
      <cdr:y>0.26137</cdr:y>
    </cdr:from>
    <cdr:to>
      <cdr:x>0.17204</cdr:x>
      <cdr:y>0.30409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291089" y="1951772"/>
          <a:ext cx="208298" cy="3190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4081</cdr:x>
      <cdr:y>0.23219</cdr:y>
    </cdr:from>
    <cdr:to>
      <cdr:x>0.16471</cdr:x>
      <cdr:y>0.26858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227240" y="1733905"/>
          <a:ext cx="208297" cy="2717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7774</cdr:x>
      <cdr:y>0.69571</cdr:y>
    </cdr:from>
    <cdr:to>
      <cdr:x>0.20289</cdr:x>
      <cdr:y>0.74001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1549050" y="5195318"/>
          <a:ext cx="219192" cy="3308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18889</cdr:x>
      <cdr:y>0.44393</cdr:y>
    </cdr:from>
    <cdr:to>
      <cdr:x>0.20902</cdr:x>
      <cdr:y>0.48982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1646252" y="3315124"/>
          <a:ext cx="175441" cy="3426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8876</cdr:x>
      <cdr:y>0.27491</cdr:y>
    </cdr:from>
    <cdr:to>
      <cdr:x>0.23506</cdr:x>
      <cdr:y>0.33985</cdr:y>
    </cdr:to>
    <cdr:sp macro="" textlink="">
      <cdr:nvSpPr>
        <cdr:cNvPr id="18" name="CasellaDiTesto 17"/>
        <cdr:cNvSpPr txBox="1"/>
      </cdr:nvSpPr>
      <cdr:spPr>
        <a:xfrm xmlns:a="http://schemas.openxmlformats.org/drawingml/2006/main" rot="16200000">
          <a:off x="1604368" y="2093619"/>
          <a:ext cx="484946" cy="4035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16478</cdr:x>
      <cdr:y>0.24051</cdr:y>
    </cdr:from>
    <cdr:to>
      <cdr:x>0.28553</cdr:x>
      <cdr:y>0.39241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1247775" y="14478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20524</cdr:x>
      <cdr:y>0.3176</cdr:y>
    </cdr:from>
    <cdr:to>
      <cdr:x>0.24918</cdr:x>
      <cdr:y>0.3701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1788749" y="2371726"/>
          <a:ext cx="382952" cy="392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0649</cdr:x>
      <cdr:y>0.18068</cdr:y>
    </cdr:from>
    <cdr:to>
      <cdr:x>0.26184</cdr:x>
      <cdr:y>0.23764</cdr:y>
    </cdr:to>
    <cdr:sp macro="" textlink="">
      <cdr:nvSpPr>
        <cdr:cNvPr id="21" name="CasellaDiTesto 20"/>
        <cdr:cNvSpPr txBox="1"/>
      </cdr:nvSpPr>
      <cdr:spPr>
        <a:xfrm xmlns:a="http://schemas.openxmlformats.org/drawingml/2006/main" rot="16200000">
          <a:off x="1828169" y="1320759"/>
          <a:ext cx="425355" cy="4823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23543</cdr:x>
      <cdr:y>0.57532</cdr:y>
    </cdr:from>
    <cdr:to>
      <cdr:x>0.26813</cdr:x>
      <cdr:y>0.61329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051866" y="4296273"/>
          <a:ext cx="284993" cy="283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4297</cdr:x>
      <cdr:y>0.42051</cdr:y>
    </cdr:from>
    <cdr:to>
      <cdr:x>0.26184</cdr:x>
      <cdr:y>0.45691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117580" y="3140191"/>
          <a:ext cx="164459" cy="2718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4549</cdr:x>
      <cdr:y>0.15859</cdr:y>
    </cdr:from>
    <cdr:to>
      <cdr:x>0.34109</cdr:x>
      <cdr:y>0.20922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2139542" y="1184302"/>
          <a:ext cx="833190" cy="3780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29203</cdr:x>
      <cdr:y>0.57343</cdr:y>
    </cdr:from>
    <cdr:to>
      <cdr:x>0.31844</cdr:x>
      <cdr:y>0.61932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2545156" y="4282126"/>
          <a:ext cx="230173" cy="3426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f</a:t>
          </a:r>
        </a:p>
      </cdr:txBody>
    </cdr:sp>
  </cdr:relSizeAnchor>
  <cdr:relSizeAnchor xmlns:cdr="http://schemas.openxmlformats.org/drawingml/2006/chartDrawing">
    <cdr:from>
      <cdr:x>0.26458</cdr:x>
      <cdr:y>0.09638</cdr:y>
    </cdr:from>
    <cdr:to>
      <cdr:x>0.31112</cdr:x>
      <cdr:y>0.14227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2305953" y="719707"/>
          <a:ext cx="405614" cy="3426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98</cdr:x>
      <cdr:y>0.47911</cdr:y>
    </cdr:from>
    <cdr:to>
      <cdr:x>0.3219</cdr:x>
      <cdr:y>0.51233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2597150" y="3577774"/>
          <a:ext cx="208298" cy="2480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30779</cdr:x>
      <cdr:y>0.29273</cdr:y>
    </cdr:from>
    <cdr:to>
      <cdr:x>0.33923</cdr:x>
      <cdr:y>0.33704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2682497" y="2185984"/>
          <a:ext cx="274011" cy="33089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1954</cdr:x>
      <cdr:y>0.20575</cdr:y>
    </cdr:from>
    <cdr:to>
      <cdr:x>0.34344</cdr:x>
      <cdr:y>0.24214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2784941" y="1536440"/>
          <a:ext cx="208298" cy="2717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4595</cdr:x>
      <cdr:y>0.62192</cdr:y>
    </cdr:from>
    <cdr:to>
      <cdr:x>0.36733</cdr:x>
      <cdr:y>0.6504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015114" y="4644219"/>
          <a:ext cx="186335" cy="2126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569</cdr:x>
      <cdr:y>0.49145</cdr:y>
    </cdr:from>
    <cdr:to>
      <cdr:x>0.37707</cdr:x>
      <cdr:y>0.5231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3099965" y="3669966"/>
          <a:ext cx="186335" cy="2363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6197</cdr:x>
      <cdr:y>0.29383</cdr:y>
    </cdr:from>
    <cdr:to>
      <cdr:x>0.38461</cdr:x>
      <cdr:y>0.33022</cdr:y>
    </cdr:to>
    <cdr:sp macro="" textlink="">
      <cdr:nvSpPr>
        <cdr:cNvPr id="36" name="CasellaDiTesto 35"/>
        <cdr:cNvSpPr txBox="1"/>
      </cdr:nvSpPr>
      <cdr:spPr>
        <a:xfrm xmlns:a="http://schemas.openxmlformats.org/drawingml/2006/main">
          <a:off x="3154698" y="2194232"/>
          <a:ext cx="197316" cy="2717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7078</cdr:x>
      <cdr:y>0.33875</cdr:y>
    </cdr:from>
    <cdr:to>
      <cdr:x>0.39594</cdr:x>
      <cdr:y>0.37514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3231480" y="2529669"/>
          <a:ext cx="219279" cy="2717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7549</cdr:x>
      <cdr:y>0.10474</cdr:y>
    </cdr:from>
    <cdr:to>
      <cdr:x>0.43964</cdr:x>
      <cdr:y>0.22341</cdr:y>
    </cdr:to>
    <cdr:sp macro="" textlink="">
      <cdr:nvSpPr>
        <cdr:cNvPr id="38" name="CasellaDiTesto 37"/>
        <cdr:cNvSpPr txBox="1"/>
      </cdr:nvSpPr>
      <cdr:spPr>
        <a:xfrm xmlns:a="http://schemas.openxmlformats.org/drawingml/2006/main" rot="16200000">
          <a:off x="3108949" y="945734"/>
          <a:ext cx="886180" cy="5590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0316</cdr:x>
      <cdr:y>0.40499</cdr:y>
    </cdr:from>
    <cdr:to>
      <cdr:x>0.44215</cdr:x>
      <cdr:y>0.46354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3513648" y="3024328"/>
          <a:ext cx="339899" cy="4372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0759</cdr:x>
      <cdr:y>0.34105</cdr:y>
    </cdr:from>
    <cdr:to>
      <cdr:x>0.43526</cdr:x>
      <cdr:y>0.38219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3552330" y="2546801"/>
          <a:ext cx="241155" cy="3072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0923</cdr:x>
      <cdr:y>0.2112</cdr:y>
    </cdr:from>
    <cdr:to>
      <cdr:x>0.49477</cdr:x>
      <cdr:y>0.30456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3566632" y="1577169"/>
          <a:ext cx="745514" cy="69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  bb</a:t>
          </a:r>
        </a:p>
      </cdr:txBody>
    </cdr:sp>
  </cdr:relSizeAnchor>
  <cdr:relSizeAnchor xmlns:cdr="http://schemas.openxmlformats.org/drawingml/2006/chartDrawing">
    <cdr:from>
      <cdr:x>0.45178</cdr:x>
      <cdr:y>0.43194</cdr:y>
    </cdr:from>
    <cdr:to>
      <cdr:x>0.48448</cdr:x>
      <cdr:y>0.46991</cdr:y>
    </cdr:to>
    <cdr:sp macro="" textlink="">
      <cdr:nvSpPr>
        <cdr:cNvPr id="45" name="CasellaDiTesto 44"/>
        <cdr:cNvSpPr txBox="1"/>
      </cdr:nvSpPr>
      <cdr:spPr>
        <a:xfrm xmlns:a="http://schemas.openxmlformats.org/drawingml/2006/main">
          <a:off x="3937437" y="3225561"/>
          <a:ext cx="284993" cy="283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46588</cdr:x>
      <cdr:y>0.29225</cdr:y>
    </cdr:from>
    <cdr:to>
      <cdr:x>0.48978</cdr:x>
      <cdr:y>0.32864</cdr:y>
    </cdr:to>
    <cdr:sp macro="" textlink="">
      <cdr:nvSpPr>
        <cdr:cNvPr id="46" name="CasellaDiTesto 45"/>
        <cdr:cNvSpPr txBox="1"/>
      </cdr:nvSpPr>
      <cdr:spPr>
        <a:xfrm xmlns:a="http://schemas.openxmlformats.org/drawingml/2006/main">
          <a:off x="4060301" y="2182434"/>
          <a:ext cx="208298" cy="2717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7267</cdr:x>
      <cdr:y>0.17982</cdr:y>
    </cdr:from>
    <cdr:to>
      <cdr:x>0.49909</cdr:x>
      <cdr:y>0.21305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4119490" y="1342813"/>
          <a:ext cx="230260" cy="2481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8256</cdr:x>
      <cdr:y>0.23872</cdr:y>
    </cdr:from>
    <cdr:to>
      <cdr:x>0.51275</cdr:x>
      <cdr:y>0.26878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4205710" y="1782670"/>
          <a:ext cx="263118" cy="2244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8667</cdr:x>
      <cdr:y>0.15201</cdr:y>
    </cdr:from>
    <cdr:to>
      <cdr:x>0.51057</cdr:x>
      <cdr:y>0.20106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4241480" y="1135113"/>
          <a:ext cx="208298" cy="3662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1408</cdr:x>
      <cdr:y>0.59228</cdr:y>
    </cdr:from>
    <cdr:to>
      <cdr:x>0.55307</cdr:x>
      <cdr:y>0.64291</cdr:y>
    </cdr:to>
    <cdr:sp macro="" textlink="">
      <cdr:nvSpPr>
        <cdr:cNvPr id="51" name="CasellaDiTesto 50"/>
        <cdr:cNvSpPr txBox="1"/>
      </cdr:nvSpPr>
      <cdr:spPr>
        <a:xfrm xmlns:a="http://schemas.openxmlformats.org/drawingml/2006/main">
          <a:off x="4480435" y="4422919"/>
          <a:ext cx="339813" cy="3780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52068</cdr:x>
      <cdr:y>0.45074</cdr:y>
    </cdr:from>
    <cdr:to>
      <cdr:x>0.54333</cdr:x>
      <cdr:y>0.49663</cdr:y>
    </cdr:to>
    <cdr:sp macro="" textlink="">
      <cdr:nvSpPr>
        <cdr:cNvPr id="52" name="CasellaDiTesto 51"/>
        <cdr:cNvSpPr txBox="1"/>
      </cdr:nvSpPr>
      <cdr:spPr>
        <a:xfrm xmlns:a="http://schemas.openxmlformats.org/drawingml/2006/main">
          <a:off x="4537956" y="3365982"/>
          <a:ext cx="197403" cy="3426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1758</cdr:x>
      <cdr:y>0.32446</cdr:y>
    </cdr:from>
    <cdr:to>
      <cdr:x>0.59557</cdr:x>
      <cdr:y>0.41781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4510907" y="2422973"/>
          <a:ext cx="679711" cy="6971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 c c</a:t>
          </a:r>
        </a:p>
      </cdr:txBody>
    </cdr:sp>
  </cdr:relSizeAnchor>
  <cdr:relSizeAnchor xmlns:cdr="http://schemas.openxmlformats.org/drawingml/2006/chartDrawing">
    <cdr:from>
      <cdr:x>0.57029</cdr:x>
      <cdr:y>0.37076</cdr:y>
    </cdr:from>
    <cdr:to>
      <cdr:x>0.59167</cdr:x>
      <cdr:y>0.41981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4970274" y="2768722"/>
          <a:ext cx="186334" cy="3662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7767</cdr:x>
      <cdr:y>0.32799</cdr:y>
    </cdr:from>
    <cdr:to>
      <cdr:x>0.60157</cdr:x>
      <cdr:y>0.36754</cdr:y>
    </cdr:to>
    <cdr:sp macro="" textlink="">
      <cdr:nvSpPr>
        <cdr:cNvPr id="56" name="CasellaDiTesto 55"/>
        <cdr:cNvSpPr txBox="1"/>
      </cdr:nvSpPr>
      <cdr:spPr>
        <a:xfrm xmlns:a="http://schemas.openxmlformats.org/drawingml/2006/main">
          <a:off x="5034618" y="2449277"/>
          <a:ext cx="208298" cy="2953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8068</cdr:x>
      <cdr:y>0.18649</cdr:y>
    </cdr:from>
    <cdr:to>
      <cdr:x>0.63099</cdr:x>
      <cdr:y>0.25137</cdr:y>
    </cdr:to>
    <cdr:sp macro="" textlink="">
      <cdr:nvSpPr>
        <cdr:cNvPr id="57" name="CasellaDiTesto 56"/>
        <cdr:cNvSpPr txBox="1"/>
      </cdr:nvSpPr>
      <cdr:spPr>
        <a:xfrm xmlns:a="http://schemas.openxmlformats.org/drawingml/2006/main">
          <a:off x="5060863" y="1392637"/>
          <a:ext cx="438471" cy="4844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62421</cdr:x>
      <cdr:y>0.57629</cdr:y>
    </cdr:from>
    <cdr:to>
      <cdr:x>0.64937</cdr:x>
      <cdr:y>0.62375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5440232" y="4303525"/>
          <a:ext cx="219279" cy="354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3301</cdr:x>
      <cdr:y>0.48885</cdr:y>
    </cdr:from>
    <cdr:to>
      <cdr:x>0.65314</cdr:x>
      <cdr:y>0.52999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5516927" y="3650561"/>
          <a:ext cx="175441" cy="3072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4331</cdr:x>
      <cdr:y>0.29687</cdr:y>
    </cdr:from>
    <cdr:to>
      <cdr:x>0.66217</cdr:x>
      <cdr:y>0.32852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5606730" y="2216908"/>
          <a:ext cx="164372" cy="2363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8144</cdr:x>
      <cdr:y>0.56139</cdr:y>
    </cdr:from>
    <cdr:to>
      <cdr:x>0.71414</cdr:x>
      <cdr:y>0.61835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5938969" y="4192209"/>
          <a:ext cx="284993" cy="4253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8603</cdr:x>
      <cdr:y>0.41858</cdr:y>
    </cdr:from>
    <cdr:to>
      <cdr:x>0.70867</cdr:x>
      <cdr:y>0.46605</cdr:y>
    </cdr:to>
    <cdr:sp macro="" textlink="">
      <cdr:nvSpPr>
        <cdr:cNvPr id="67" name="CasellaDiTesto 66"/>
        <cdr:cNvSpPr txBox="1"/>
      </cdr:nvSpPr>
      <cdr:spPr>
        <a:xfrm xmlns:a="http://schemas.openxmlformats.org/drawingml/2006/main">
          <a:off x="5979021" y="3125764"/>
          <a:ext cx="197316" cy="3544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9686</cdr:x>
      <cdr:y>0.23234</cdr:y>
    </cdr:from>
    <cdr:to>
      <cdr:x>0.72453</cdr:x>
      <cdr:y>0.28139</cdr:y>
    </cdr:to>
    <cdr:sp macro="" textlink="">
      <cdr:nvSpPr>
        <cdr:cNvPr id="68" name="CasellaDiTesto 67"/>
        <cdr:cNvSpPr txBox="1"/>
      </cdr:nvSpPr>
      <cdr:spPr>
        <a:xfrm xmlns:a="http://schemas.openxmlformats.org/drawingml/2006/main">
          <a:off x="6073397" y="1735045"/>
          <a:ext cx="241154" cy="3662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0254</cdr:x>
      <cdr:y>0.27792</cdr:y>
    </cdr:from>
    <cdr:to>
      <cdr:x>0.75412</cdr:x>
      <cdr:y>0.34595</cdr:y>
    </cdr:to>
    <cdr:sp macro="" textlink="">
      <cdr:nvSpPr>
        <cdr:cNvPr id="69" name="CasellaDiTesto 68"/>
        <cdr:cNvSpPr txBox="1"/>
      </cdr:nvSpPr>
      <cdr:spPr>
        <a:xfrm xmlns:a="http://schemas.openxmlformats.org/drawingml/2006/main" rot="16200000">
          <a:off x="6093648" y="2104626"/>
          <a:ext cx="508021" cy="4495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73583</cdr:x>
      <cdr:y>0.61461</cdr:y>
    </cdr:from>
    <cdr:to>
      <cdr:x>0.76351</cdr:x>
      <cdr:y>0.64468</cdr:y>
    </cdr:to>
    <cdr:sp macro="" textlink="">
      <cdr:nvSpPr>
        <cdr:cNvPr id="71" name="CasellaDiTesto 70"/>
        <cdr:cNvSpPr txBox="1"/>
      </cdr:nvSpPr>
      <cdr:spPr>
        <a:xfrm xmlns:a="http://schemas.openxmlformats.org/drawingml/2006/main">
          <a:off x="6413006" y="4589698"/>
          <a:ext cx="241241" cy="2245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7448</cdr:x>
      <cdr:y>0.48759</cdr:y>
    </cdr:from>
    <cdr:to>
      <cdr:x>0.76241</cdr:x>
      <cdr:y>0.53189</cdr:y>
    </cdr:to>
    <cdr:sp macro="" textlink="">
      <cdr:nvSpPr>
        <cdr:cNvPr id="72" name="CasellaDiTesto 71"/>
        <cdr:cNvSpPr txBox="1"/>
      </cdr:nvSpPr>
      <cdr:spPr>
        <a:xfrm xmlns:a="http://schemas.openxmlformats.org/drawingml/2006/main">
          <a:off x="6491244" y="3641110"/>
          <a:ext cx="153478" cy="3308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5235</cdr:x>
      <cdr:y>0.30558</cdr:y>
    </cdr:from>
    <cdr:to>
      <cdr:x>0.77625</cdr:x>
      <cdr:y>0.36254</cdr:y>
    </cdr:to>
    <cdr:sp macro="" textlink="">
      <cdr:nvSpPr>
        <cdr:cNvPr id="73" name="CasellaDiTesto 72"/>
        <cdr:cNvSpPr txBox="1"/>
      </cdr:nvSpPr>
      <cdr:spPr>
        <a:xfrm xmlns:a="http://schemas.openxmlformats.org/drawingml/2006/main">
          <a:off x="6557045" y="2281951"/>
          <a:ext cx="208298" cy="4253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5896</cdr:x>
      <cdr:y>0.36504</cdr:y>
    </cdr:from>
    <cdr:to>
      <cdr:x>0.79167</cdr:x>
      <cdr:y>0.40301</cdr:y>
    </cdr:to>
    <cdr:sp macro="" textlink="">
      <cdr:nvSpPr>
        <cdr:cNvPr id="74" name="CasellaDiTesto 73"/>
        <cdr:cNvSpPr txBox="1"/>
      </cdr:nvSpPr>
      <cdr:spPr>
        <a:xfrm xmlns:a="http://schemas.openxmlformats.org/drawingml/2006/main">
          <a:off x="6614604" y="2726000"/>
          <a:ext cx="285080" cy="283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651</cdr:x>
      <cdr:y>0.12316</cdr:y>
    </cdr:from>
    <cdr:to>
      <cdr:x>0.81163</cdr:x>
      <cdr:y>0.17062</cdr:y>
    </cdr:to>
    <cdr:sp macro="" textlink="">
      <cdr:nvSpPr>
        <cdr:cNvPr id="75" name="CasellaDiTesto 74"/>
        <cdr:cNvSpPr txBox="1"/>
      </cdr:nvSpPr>
      <cdr:spPr>
        <a:xfrm xmlns:a="http://schemas.openxmlformats.org/drawingml/2006/main">
          <a:off x="6668141" y="919732"/>
          <a:ext cx="405527" cy="3544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79118</cdr:x>
      <cdr:y>0.74416</cdr:y>
    </cdr:from>
    <cdr:to>
      <cdr:x>0.81633</cdr:x>
      <cdr:y>0.79005</cdr:y>
    </cdr:to>
    <cdr:sp macro="" textlink="">
      <cdr:nvSpPr>
        <cdr:cNvPr id="77" name="CasellaDiTesto 76"/>
        <cdr:cNvSpPr txBox="1"/>
      </cdr:nvSpPr>
      <cdr:spPr>
        <a:xfrm xmlns:a="http://schemas.openxmlformats.org/drawingml/2006/main">
          <a:off x="6895402" y="5557056"/>
          <a:ext cx="219191" cy="3426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0064</cdr:x>
      <cdr:y>0.58961</cdr:y>
    </cdr:from>
    <cdr:to>
      <cdr:x>0.82951</cdr:x>
      <cdr:y>0.62758</cdr:y>
    </cdr:to>
    <cdr:sp macro="" textlink="">
      <cdr:nvSpPr>
        <cdr:cNvPr id="78" name="CasellaDiTesto 77"/>
        <cdr:cNvSpPr txBox="1"/>
      </cdr:nvSpPr>
      <cdr:spPr>
        <a:xfrm xmlns:a="http://schemas.openxmlformats.org/drawingml/2006/main">
          <a:off x="6977922" y="4402967"/>
          <a:ext cx="251554" cy="283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0895</cdr:x>
      <cdr:y>0.31379</cdr:y>
    </cdr:from>
    <cdr:to>
      <cdr:x>0.83033</cdr:x>
      <cdr:y>0.35809</cdr:y>
    </cdr:to>
    <cdr:sp macro="" textlink="">
      <cdr:nvSpPr>
        <cdr:cNvPr id="79" name="CasellaDiTesto 78"/>
        <cdr:cNvSpPr txBox="1"/>
      </cdr:nvSpPr>
      <cdr:spPr>
        <a:xfrm xmlns:a="http://schemas.openxmlformats.org/drawingml/2006/main">
          <a:off x="7050336" y="2343293"/>
          <a:ext cx="186335" cy="3308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1649</cdr:x>
      <cdr:y>0.40423</cdr:y>
    </cdr:from>
    <cdr:to>
      <cdr:x>0.84542</cdr:x>
      <cdr:y>0.44537</cdr:y>
    </cdr:to>
    <cdr:sp macro="" textlink="">
      <cdr:nvSpPr>
        <cdr:cNvPr id="80" name="CasellaDiTesto 79"/>
        <cdr:cNvSpPr txBox="1"/>
      </cdr:nvSpPr>
      <cdr:spPr>
        <a:xfrm xmlns:a="http://schemas.openxmlformats.org/drawingml/2006/main">
          <a:off x="7116050" y="3018640"/>
          <a:ext cx="252136" cy="3072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4794</cdr:x>
      <cdr:y>0.58262</cdr:y>
    </cdr:from>
    <cdr:to>
      <cdr:x>0.86806</cdr:x>
      <cdr:y>0.62534</cdr:y>
    </cdr:to>
    <cdr:sp macro="" textlink="">
      <cdr:nvSpPr>
        <cdr:cNvPr id="82" name="CasellaDiTesto 81"/>
        <cdr:cNvSpPr txBox="1"/>
      </cdr:nvSpPr>
      <cdr:spPr>
        <a:xfrm xmlns:a="http://schemas.openxmlformats.org/drawingml/2006/main">
          <a:off x="7390148" y="4350794"/>
          <a:ext cx="175354" cy="3190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5642</cdr:x>
      <cdr:y>0.46421</cdr:y>
    </cdr:from>
    <cdr:to>
      <cdr:x>0.88031</cdr:x>
      <cdr:y>0.51009</cdr:y>
    </cdr:to>
    <cdr:sp macro="" textlink="">
      <cdr:nvSpPr>
        <cdr:cNvPr id="83" name="CasellaDiTesto 82"/>
        <cdr:cNvSpPr txBox="1"/>
      </cdr:nvSpPr>
      <cdr:spPr>
        <a:xfrm xmlns:a="http://schemas.openxmlformats.org/drawingml/2006/main">
          <a:off x="7464018" y="3466533"/>
          <a:ext cx="208210" cy="3426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6091</cdr:x>
      <cdr:y>0.28404</cdr:y>
    </cdr:from>
    <cdr:to>
      <cdr:x>0.88104</cdr:x>
      <cdr:y>0.3141</cdr:y>
    </cdr:to>
    <cdr:sp macro="" textlink="">
      <cdr:nvSpPr>
        <cdr:cNvPr id="84" name="CasellaDiTesto 83"/>
        <cdr:cNvSpPr txBox="1"/>
      </cdr:nvSpPr>
      <cdr:spPr>
        <a:xfrm xmlns:a="http://schemas.openxmlformats.org/drawingml/2006/main">
          <a:off x="7503196" y="2121091"/>
          <a:ext cx="175440" cy="2244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2268</cdr:x>
      <cdr:y>0.17351</cdr:y>
    </cdr:from>
    <cdr:to>
      <cdr:x>0.84784</cdr:x>
      <cdr:y>0.202</cdr:y>
    </cdr:to>
    <cdr:sp macro="" textlink="">
      <cdr:nvSpPr>
        <cdr:cNvPr id="86" name="CasellaDiTesto 85"/>
        <cdr:cNvSpPr txBox="1"/>
      </cdr:nvSpPr>
      <cdr:spPr>
        <a:xfrm xmlns:a="http://schemas.openxmlformats.org/drawingml/2006/main">
          <a:off x="7169996" y="1295680"/>
          <a:ext cx="219278" cy="2127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0917</cdr:x>
      <cdr:y>0.12277</cdr:y>
    </cdr:from>
    <cdr:to>
      <cdr:x>0.13582</cdr:x>
      <cdr:y>0.15576</cdr:y>
    </cdr:to>
    <cdr:sp macro="" textlink="">
      <cdr:nvSpPr>
        <cdr:cNvPr id="93" name="CasellaDiTesto 7"/>
        <cdr:cNvSpPr txBox="1"/>
      </cdr:nvSpPr>
      <cdr:spPr>
        <a:xfrm xmlns:a="http://schemas.openxmlformats.org/drawingml/2006/main">
          <a:off x="951497" y="916800"/>
          <a:ext cx="232264" cy="2463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51</cdr:x>
      <cdr:y>0.09515</cdr:y>
    </cdr:from>
    <cdr:to>
      <cdr:x>0.18144</cdr:x>
      <cdr:y>0.127</cdr:y>
    </cdr:to>
    <cdr:sp macro="" textlink="">
      <cdr:nvSpPr>
        <cdr:cNvPr id="96" name="CasellaDiTesto 10"/>
        <cdr:cNvSpPr txBox="1"/>
      </cdr:nvSpPr>
      <cdr:spPr>
        <a:xfrm xmlns:a="http://schemas.openxmlformats.org/drawingml/2006/main">
          <a:off x="1316058" y="710568"/>
          <a:ext cx="265296" cy="237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7699</cdr:x>
      <cdr:y>0.12372</cdr:y>
    </cdr:from>
    <cdr:to>
      <cdr:x>0.30601</cdr:x>
      <cdr:y>0.15619</cdr:y>
    </cdr:to>
    <cdr:sp macro="" textlink="">
      <cdr:nvSpPr>
        <cdr:cNvPr id="106" name="CasellaDiTesto 20"/>
        <cdr:cNvSpPr txBox="1"/>
      </cdr:nvSpPr>
      <cdr:spPr>
        <a:xfrm xmlns:a="http://schemas.openxmlformats.org/drawingml/2006/main">
          <a:off x="2414035" y="923925"/>
          <a:ext cx="252966" cy="24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305</cdr:x>
      <cdr:y>0.12347</cdr:y>
    </cdr:from>
    <cdr:to>
      <cdr:x>0.35239</cdr:x>
      <cdr:y>0.15988</cdr:y>
    </cdr:to>
    <cdr:sp macro="" textlink="">
      <cdr:nvSpPr>
        <cdr:cNvPr id="113" name="CasellaDiTesto 28"/>
        <cdr:cNvSpPr txBox="1"/>
      </cdr:nvSpPr>
      <cdr:spPr>
        <a:xfrm xmlns:a="http://schemas.openxmlformats.org/drawingml/2006/main">
          <a:off x="2880420" y="922028"/>
          <a:ext cx="190780" cy="2718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8453</cdr:x>
      <cdr:y>0.12232</cdr:y>
    </cdr:from>
    <cdr:to>
      <cdr:x>0.41022</cdr:x>
      <cdr:y>0.15076</cdr:y>
    </cdr:to>
    <cdr:sp macro="" textlink="">
      <cdr:nvSpPr>
        <cdr:cNvPr id="117" name="CasellaDiTesto 32"/>
        <cdr:cNvSpPr txBox="1"/>
      </cdr:nvSpPr>
      <cdr:spPr>
        <a:xfrm xmlns:a="http://schemas.openxmlformats.org/drawingml/2006/main">
          <a:off x="3351349" y="913422"/>
          <a:ext cx="223898" cy="2123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3309</cdr:x>
      <cdr:y>0.14762</cdr:y>
    </cdr:from>
    <cdr:to>
      <cdr:x>0.45117</cdr:x>
      <cdr:y>0.18175</cdr:y>
    </cdr:to>
    <cdr:sp macro="" textlink="">
      <cdr:nvSpPr>
        <cdr:cNvPr id="122" name="CasellaDiTesto 37"/>
        <cdr:cNvSpPr txBox="1"/>
      </cdr:nvSpPr>
      <cdr:spPr>
        <a:xfrm xmlns:a="http://schemas.openxmlformats.org/drawingml/2006/main">
          <a:off x="3774570" y="1102359"/>
          <a:ext cx="157574" cy="2548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6708</cdr:x>
      <cdr:y>0.2446</cdr:y>
    </cdr:from>
    <cdr:to>
      <cdr:x>0.5842</cdr:x>
      <cdr:y>0.2719</cdr:y>
    </cdr:to>
    <cdr:sp macro="" textlink="">
      <cdr:nvSpPr>
        <cdr:cNvPr id="133" name="CasellaDiTesto 48"/>
        <cdr:cNvSpPr txBox="1"/>
      </cdr:nvSpPr>
      <cdr:spPr>
        <a:xfrm xmlns:a="http://schemas.openxmlformats.org/drawingml/2006/main">
          <a:off x="5676955" y="2047927"/>
          <a:ext cx="171384" cy="2285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0225</cdr:x>
      <cdr:y>0.03289</cdr:y>
    </cdr:from>
    <cdr:to>
      <cdr:x>0.62984</cdr:x>
      <cdr:y>0.06361</cdr:y>
    </cdr:to>
    <cdr:sp macro="" textlink="">
      <cdr:nvSpPr>
        <cdr:cNvPr id="136" name="CasellaDiTesto 52"/>
        <cdr:cNvSpPr txBox="1"/>
      </cdr:nvSpPr>
      <cdr:spPr>
        <a:xfrm xmlns:a="http://schemas.openxmlformats.org/drawingml/2006/main">
          <a:off x="5248833" y="245585"/>
          <a:ext cx="240457" cy="2294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206</cdr:x>
      <cdr:y>0.07319</cdr:y>
    </cdr:from>
    <cdr:to>
      <cdr:x>0.70536</cdr:x>
      <cdr:y>0.11983</cdr:y>
    </cdr:to>
    <cdr:sp macro="" textlink="">
      <cdr:nvSpPr>
        <cdr:cNvPr id="141" name="CasellaDiTesto 1"/>
        <cdr:cNvSpPr txBox="1"/>
      </cdr:nvSpPr>
      <cdr:spPr>
        <a:xfrm xmlns:a="http://schemas.openxmlformats.org/drawingml/2006/main" rot="16200000">
          <a:off x="6699250" y="641350"/>
          <a:ext cx="39052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83092</cdr:x>
      <cdr:y>0.12473</cdr:y>
    </cdr:from>
    <cdr:to>
      <cdr:x>0.85376</cdr:x>
      <cdr:y>0.15658</cdr:y>
    </cdr:to>
    <cdr:sp macro="" textlink="">
      <cdr:nvSpPr>
        <cdr:cNvPr id="152" name="CasellaDiTesto 68"/>
        <cdr:cNvSpPr txBox="1"/>
      </cdr:nvSpPr>
      <cdr:spPr>
        <a:xfrm xmlns:a="http://schemas.openxmlformats.org/drawingml/2006/main">
          <a:off x="7241744" y="931460"/>
          <a:ext cx="199059" cy="237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9685</cdr:x>
      <cdr:y>0.12411</cdr:y>
    </cdr:from>
    <cdr:to>
      <cdr:x>0.51778</cdr:x>
      <cdr:y>0.14914</cdr:y>
    </cdr:to>
    <cdr:sp macro="" textlink="">
      <cdr:nvSpPr>
        <cdr:cNvPr id="163" name="CasellaDiTesto 79"/>
        <cdr:cNvSpPr txBox="1"/>
      </cdr:nvSpPr>
      <cdr:spPr>
        <a:xfrm xmlns:a="http://schemas.openxmlformats.org/drawingml/2006/main">
          <a:off x="4330235" y="926789"/>
          <a:ext cx="182412" cy="1869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556</cdr:x>
      <cdr:y>0.125</cdr:y>
    </cdr:from>
    <cdr:to>
      <cdr:x>0.24481</cdr:x>
      <cdr:y>0.16182</cdr:y>
    </cdr:to>
    <cdr:sp macro="" textlink="">
      <cdr:nvSpPr>
        <cdr:cNvPr id="164" name="TextBox 80">
          <a:extLst xmlns:a="http://schemas.openxmlformats.org/drawingml/2006/main">
            <a:ext uri="{FF2B5EF4-FFF2-40B4-BE49-F238E27FC236}">
              <a16:creationId xmlns="" xmlns:a16="http://schemas.microsoft.com/office/drawing/2014/main" id="{BD8718A6-0CDB-4DAB-B675-0EE421BD3A76}"/>
            </a:ext>
          </a:extLst>
        </cdr:cNvPr>
        <cdr:cNvSpPr txBox="1"/>
      </cdr:nvSpPr>
      <cdr:spPr>
        <a:xfrm xmlns:a="http://schemas.openxmlformats.org/drawingml/2006/main">
          <a:off x="1878697" y="933450"/>
          <a:ext cx="254903" cy="2749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3</cdr:x>
      <cdr:y>0.12218</cdr:y>
    </cdr:from>
    <cdr:to>
      <cdr:x>0.46393</cdr:x>
      <cdr:y>0.14721</cdr:y>
    </cdr:to>
    <cdr:sp macro="" textlink="">
      <cdr:nvSpPr>
        <cdr:cNvPr id="165" name="TextBox 81">
          <a:extLst xmlns:a="http://schemas.openxmlformats.org/drawingml/2006/main">
            <a:ext uri="{FF2B5EF4-FFF2-40B4-BE49-F238E27FC236}">
              <a16:creationId xmlns="" xmlns:a16="http://schemas.microsoft.com/office/drawing/2014/main" id="{759D98BD-6B28-4FD2-A59A-C28A96105C8F}"/>
            </a:ext>
          </a:extLst>
        </cdr:cNvPr>
        <cdr:cNvSpPr txBox="1"/>
      </cdr:nvSpPr>
      <cdr:spPr>
        <a:xfrm xmlns:a="http://schemas.openxmlformats.org/drawingml/2006/main">
          <a:off x="3860925" y="912410"/>
          <a:ext cx="182413" cy="1869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8406</cdr:x>
      <cdr:y>0.12218</cdr:y>
    </cdr:from>
    <cdr:to>
      <cdr:x>0.90595</cdr:x>
      <cdr:y>0.15403</cdr:y>
    </cdr:to>
    <cdr:sp macro="" textlink="">
      <cdr:nvSpPr>
        <cdr:cNvPr id="170" name="TextBox 86">
          <a:extLst xmlns:a="http://schemas.openxmlformats.org/drawingml/2006/main">
            <a:ext uri="{FF2B5EF4-FFF2-40B4-BE49-F238E27FC236}">
              <a16:creationId xmlns="" xmlns:a16="http://schemas.microsoft.com/office/drawing/2014/main" id="{0F9EC9A7-FA94-4402-BC0E-7940AC6E830C}"/>
            </a:ext>
          </a:extLst>
        </cdr:cNvPr>
        <cdr:cNvSpPr txBox="1"/>
      </cdr:nvSpPr>
      <cdr:spPr>
        <a:xfrm xmlns:a="http://schemas.openxmlformats.org/drawingml/2006/main">
          <a:off x="7704941" y="912410"/>
          <a:ext cx="190779" cy="237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6193</cdr:x>
      <cdr:y>0.125</cdr:y>
    </cdr:from>
    <cdr:to>
      <cdr:x>0.19781</cdr:x>
      <cdr:y>0.16527</cdr:y>
    </cdr:to>
    <cdr:sp macro="" textlink="">
      <cdr:nvSpPr>
        <cdr:cNvPr id="182" name="CasellaDiTesto 10"/>
        <cdr:cNvSpPr txBox="1"/>
      </cdr:nvSpPr>
      <cdr:spPr>
        <a:xfrm xmlns:a="http://schemas.openxmlformats.org/drawingml/2006/main">
          <a:off x="1411308" y="933450"/>
          <a:ext cx="312718" cy="3007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1738</cdr:x>
      <cdr:y>0.35587</cdr:y>
    </cdr:from>
    <cdr:to>
      <cdr:x>0.34317</cdr:x>
      <cdr:y>0.38514</cdr:y>
    </cdr:to>
    <cdr:sp macro="" textlink="">
      <cdr:nvSpPr>
        <cdr:cNvPr id="194" name="CasellaDiTesto 23"/>
        <cdr:cNvSpPr txBox="1"/>
      </cdr:nvSpPr>
      <cdr:spPr>
        <a:xfrm xmlns:a="http://schemas.openxmlformats.org/drawingml/2006/main">
          <a:off x="2766082" y="2657475"/>
          <a:ext cx="224769" cy="218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4263</cdr:x>
      <cdr:y>0.19307</cdr:y>
    </cdr:from>
    <cdr:to>
      <cdr:x>0.56356</cdr:x>
      <cdr:y>0.22265</cdr:y>
    </cdr:to>
    <cdr:sp macro="" textlink="">
      <cdr:nvSpPr>
        <cdr:cNvPr id="217" name="CasellaDiTesto 46"/>
        <cdr:cNvSpPr txBox="1"/>
      </cdr:nvSpPr>
      <cdr:spPr>
        <a:xfrm xmlns:a="http://schemas.openxmlformats.org/drawingml/2006/main">
          <a:off x="4729188" y="1441734"/>
          <a:ext cx="182413" cy="2208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544</cdr:x>
      <cdr:y>0.36441</cdr:y>
    </cdr:from>
    <cdr:to>
      <cdr:x>0.66963</cdr:x>
      <cdr:y>0.39057</cdr:y>
    </cdr:to>
    <cdr:sp macro="" textlink="">
      <cdr:nvSpPr>
        <cdr:cNvPr id="223" name="CasellaDiTesto 53"/>
        <cdr:cNvSpPr txBox="1"/>
      </cdr:nvSpPr>
      <cdr:spPr>
        <a:xfrm xmlns:a="http://schemas.openxmlformats.org/drawingml/2006/main">
          <a:off x="5703352" y="2721235"/>
          <a:ext cx="132735" cy="1953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546</cdr:x>
      <cdr:y>0.19943</cdr:y>
    </cdr:from>
    <cdr:to>
      <cdr:x>0.67648</cdr:x>
      <cdr:y>0.23128</cdr:y>
    </cdr:to>
    <cdr:sp macro="" textlink="">
      <cdr:nvSpPr>
        <cdr:cNvPr id="224" name="CasellaDiTesto 54"/>
        <cdr:cNvSpPr txBox="1"/>
      </cdr:nvSpPr>
      <cdr:spPr>
        <a:xfrm xmlns:a="http://schemas.openxmlformats.org/drawingml/2006/main">
          <a:off x="5705067" y="1489285"/>
          <a:ext cx="190692" cy="237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7206</cdr:x>
      <cdr:y>0.07319</cdr:y>
    </cdr:from>
    <cdr:to>
      <cdr:x>0.70536</cdr:x>
      <cdr:y>0.11983</cdr:y>
    </cdr:to>
    <cdr:sp macro="" textlink="">
      <cdr:nvSpPr>
        <cdr:cNvPr id="227" name="CasellaDiTesto 1"/>
        <cdr:cNvSpPr txBox="1"/>
      </cdr:nvSpPr>
      <cdr:spPr>
        <a:xfrm xmlns:a="http://schemas.openxmlformats.org/drawingml/2006/main" rot="16200000">
          <a:off x="6699250" y="641350"/>
          <a:ext cx="39052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71001</cdr:x>
      <cdr:y>0.12</cdr:y>
    </cdr:from>
    <cdr:to>
      <cdr:x>0.75283</cdr:x>
      <cdr:y>0.15754</cdr:y>
    </cdr:to>
    <cdr:sp macro="" textlink="">
      <cdr:nvSpPr>
        <cdr:cNvPr id="231" name="CasellaDiTesto 61"/>
        <cdr:cNvSpPr txBox="1"/>
      </cdr:nvSpPr>
      <cdr:spPr>
        <a:xfrm xmlns:a="http://schemas.openxmlformats.org/drawingml/2006/main">
          <a:off x="6188034" y="896127"/>
          <a:ext cx="373193" cy="2803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87413</cdr:x>
      <cdr:y>0.30959</cdr:y>
    </cdr:from>
    <cdr:to>
      <cdr:x>0.8884</cdr:x>
      <cdr:y>0.33689</cdr:y>
    </cdr:to>
    <cdr:sp macro="" textlink="">
      <cdr:nvSpPr>
        <cdr:cNvPr id="245" name="CasellaDiTesto 75"/>
        <cdr:cNvSpPr txBox="1"/>
      </cdr:nvSpPr>
      <cdr:spPr>
        <a:xfrm xmlns:a="http://schemas.openxmlformats.org/drawingml/2006/main">
          <a:off x="7618393" y="2311861"/>
          <a:ext cx="124368" cy="2038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7554</cdr:x>
      <cdr:y>0.15882</cdr:y>
    </cdr:from>
    <cdr:to>
      <cdr:x>0.90503</cdr:x>
      <cdr:y>0.20026</cdr:y>
    </cdr:to>
    <cdr:sp macro="" textlink="">
      <cdr:nvSpPr>
        <cdr:cNvPr id="248" name="CasellaDiTesto 78"/>
        <cdr:cNvSpPr txBox="1"/>
      </cdr:nvSpPr>
      <cdr:spPr>
        <a:xfrm xmlns:a="http://schemas.openxmlformats.org/drawingml/2006/main">
          <a:off x="7630688" y="1185986"/>
          <a:ext cx="257016" cy="3094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884</cdr:x>
      <cdr:y>0.13083</cdr:y>
    </cdr:from>
    <cdr:to>
      <cdr:x>0.23692</cdr:x>
      <cdr:y>0.15927</cdr:y>
    </cdr:to>
    <cdr:sp macro="" textlink="">
      <cdr:nvSpPr>
        <cdr:cNvPr id="250" name="TextBox 80">
          <a:extLst xmlns:a="http://schemas.openxmlformats.org/drawingml/2006/main">
            <a:ext uri="{FF2B5EF4-FFF2-40B4-BE49-F238E27FC236}">
              <a16:creationId xmlns="" xmlns:a16="http://schemas.microsoft.com/office/drawing/2014/main" id="{BD8718A6-0CDB-4DAB-B675-0EE421BD3A76}"/>
            </a:ext>
          </a:extLst>
        </cdr:cNvPr>
        <cdr:cNvSpPr txBox="1"/>
      </cdr:nvSpPr>
      <cdr:spPr>
        <a:xfrm xmlns:a="http://schemas.openxmlformats.org/drawingml/2006/main">
          <a:off x="2190753" y="1095371"/>
          <a:ext cx="180995" cy="238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55086</cdr:x>
      <cdr:y>0.12248</cdr:y>
    </cdr:from>
    <cdr:to>
      <cdr:x>0.5737</cdr:x>
      <cdr:y>0.15889</cdr:y>
    </cdr:to>
    <cdr:sp macro="" textlink="">
      <cdr:nvSpPr>
        <cdr:cNvPr id="252" name="TextBox 82">
          <a:extLst xmlns:a="http://schemas.openxmlformats.org/drawingml/2006/main">
            <a:ext uri="{FF2B5EF4-FFF2-40B4-BE49-F238E27FC236}">
              <a16:creationId xmlns="" xmlns:a16="http://schemas.microsoft.com/office/drawing/2014/main" id="{C8E99514-3D0D-437B-9E82-749F738422A4}"/>
            </a:ext>
          </a:extLst>
        </cdr:cNvPr>
        <cdr:cNvSpPr txBox="1"/>
      </cdr:nvSpPr>
      <cdr:spPr>
        <a:xfrm xmlns:a="http://schemas.openxmlformats.org/drawingml/2006/main">
          <a:off x="4800986" y="914607"/>
          <a:ext cx="199059" cy="2718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6141</cdr:x>
      <cdr:y>0.11566</cdr:y>
    </cdr:from>
    <cdr:to>
      <cdr:x>0.6833</cdr:x>
      <cdr:y>0.15662</cdr:y>
    </cdr:to>
    <cdr:sp macro="" textlink="">
      <cdr:nvSpPr>
        <cdr:cNvPr id="255" name="TextBox 85">
          <a:extLst xmlns:a="http://schemas.openxmlformats.org/drawingml/2006/main">
            <a:ext uri="{FF2B5EF4-FFF2-40B4-BE49-F238E27FC236}">
              <a16:creationId xmlns="" xmlns:a16="http://schemas.microsoft.com/office/drawing/2014/main" id="{1FCBAAA2-53DE-4840-970A-3BE9BE6971D9}"/>
            </a:ext>
          </a:extLst>
        </cdr:cNvPr>
        <cdr:cNvSpPr txBox="1"/>
      </cdr:nvSpPr>
      <cdr:spPr>
        <a:xfrm xmlns:a="http://schemas.openxmlformats.org/drawingml/2006/main">
          <a:off x="5764462" y="863698"/>
          <a:ext cx="190780" cy="3058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4644008" y="0"/>
            <a:ext cx="4392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smtClean="0"/>
              <a:t>               </a:t>
            </a:r>
            <a:r>
              <a:rPr lang="en-GB" b="1" smtClean="0"/>
              <a:t>Honokiol</a:t>
            </a:r>
            <a:r>
              <a:rPr lang="en-GB" b="1" dirty="0" smtClean="0"/>
              <a:t>  </a:t>
            </a:r>
            <a:r>
              <a:rPr lang="en-GB" b="1" dirty="0" smtClean="0"/>
              <a:t>2-monoacetate </a:t>
            </a:r>
            <a:r>
              <a:rPr lang="en-GB" b="1" dirty="0"/>
              <a:t>5</a:t>
            </a:r>
          </a:p>
        </p:txBody>
      </p:sp>
      <p:graphicFrame>
        <p:nvGraphicFramePr>
          <p:cNvPr id="7" name="Grafico 6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8336439"/>
              </p:ext>
            </p:extLst>
          </p:nvPr>
        </p:nvGraphicFramePr>
        <p:xfrm>
          <a:off x="251520" y="0"/>
          <a:ext cx="8102104" cy="6456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87971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</TotalTime>
  <Words>102</Words>
  <Application>Microsoft Office PowerPoint</Application>
  <PresentationFormat>Presentazione su schermo 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5</cp:revision>
  <dcterms:created xsi:type="dcterms:W3CDTF">2019-06-04T18:45:56Z</dcterms:created>
  <dcterms:modified xsi:type="dcterms:W3CDTF">2019-08-20T09:27:45Z</dcterms:modified>
</cp:coreProperties>
</file>